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69" autoAdjust="0"/>
    <p:restoredTop sz="94660"/>
  </p:normalViewPr>
  <p:slideViewPr>
    <p:cSldViewPr snapToGrid="0">
      <p:cViewPr varScale="1">
        <p:scale>
          <a:sx n="70" d="100"/>
          <a:sy n="70" d="100"/>
        </p:scale>
        <p:origin x="810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F8291A-4B73-E0B9-246B-2B4715E284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AC15879-D703-7FA8-E325-8C5DA2A4ED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0ECA6F-9C35-ABCF-62CD-2354293DF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78FADE-08D5-5B54-713B-0A9E93B4C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7CE17E-A6CD-7278-6A4B-9826808F1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3886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91963F-048C-6422-EFD9-D638AE895A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583E2B3-18C5-D669-DAE7-0B31B27DA7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61FDE8-8B08-3608-02C5-9D590E663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70B07C-0D82-212D-14C2-153BED4947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024FCB-B890-25A7-71D0-A601DA8AD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1516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70C701F-3AD3-C3FA-01D9-27E014CC65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3F7898-3E4C-BB98-A0B3-502A7CB3E9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4DD0BD-5183-560D-A64A-08B61E9DE9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68A0D1-D88E-B913-5539-2CA9C3DFB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9C8683-1981-CBD2-E52D-20759EECF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483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19B031-AB4A-0D2C-0E44-E7924109B4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E43F8B6-ED2E-FEE8-4B90-C2871F01E8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5F66A5-3058-8DC3-06E1-68058B53C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6D6D04-2676-B5F9-5B9C-FFC448D0C0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999DD4-5B82-6571-3F49-7FCADFBCE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4692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A79D9A-D541-CC36-F031-1663054A0C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52D4D13-185B-1AB0-64CA-CF54AA0A63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22DB9F-A0E5-DB93-7AA5-C331AFF4F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5A09BED-81F8-B8CF-E144-9707A2131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56476A-A3F0-0537-604A-CC2B19360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0246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BAFEF9-F69A-FD3B-4935-9FA3DB179B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8AED90-1413-CE3A-41E4-C1FFEB31CF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310AC68-FA51-15B6-E884-84810A793F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DAC852E-4127-A904-5C6E-FA0AFE8891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7B14E75-7FFC-7874-2887-3606AD0077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53C58D1-5B30-9280-44B9-2A6E120AD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8814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3B893C-2904-2339-8FE6-5F343BA92A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3CADEBC-A2A1-372A-BFB0-1A16224141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3EA1240-DBDB-4AFE-0D80-E61B637142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94B0069-C202-74AD-2941-F3309AC56C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61EF248-B41D-4EFA-2948-C11CFD9107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527CFC9-4D45-6F6B-5AF0-A4B5ADAC2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E0D7B79-4868-ACBF-6A1F-C1C773C64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E175AF9-2EC0-7833-9E58-B88A6DEE3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4001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9002AA-428A-A7BB-3C77-654A154909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F78AD8B-9FAF-13CC-A87E-B1DD2FBF0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39BF80C-4948-E552-1ABE-BF26F7DE9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11A24BE-3FFD-78DC-EC8A-D0ECA5438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7951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5B25D90-E00B-9D60-224E-15930E16A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A2E46C8-EBF3-5B9F-CC4D-E29C25F63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5E51892-F272-8568-1A9F-9C57EAA6B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080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E6E506-F71B-2EC1-8CBE-D8502153F9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AE49F19-D91A-A0E0-78B3-9094870CD3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9D1E91B-1E98-42EB-8957-5BB459282B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02E7C0A-1FC6-F30A-3B48-0D6BA5F0C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D5F07BE-F658-4BC9-242A-BCC4D5028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44A7282-1BD4-2309-F083-41FF95AE2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3492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B194AB-38EE-9A73-C71F-2C3FAF0FF3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174B325-B081-13D4-86A2-11D2F711E9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3F628B2-3982-83D1-637C-0B9F968B78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1AA02CC-B17C-C3DD-0E18-038A83DA5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BCE466-1A0A-0417-A13D-79E1C14792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84E7793-2E9E-BA58-C931-EE787BBA2F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1740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95FC6A1-4AB5-CE85-02EA-63135BEF5F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672B696-573B-CBCE-8707-8D6F5A3995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858060-BB0E-4508-2341-0E7E60BCE5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034FD-EBF0-4F25-9906-DF701415D35D}" type="datetimeFigureOut">
              <a:rPr lang="zh-CN" altLang="en-US" smtClean="0"/>
              <a:t>2025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3FCABBD-4639-921F-55AB-D30FEFD210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E4F250-A02B-183E-FA7F-9D41CCBAF7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07A28-7022-408B-9D56-6761C7C846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8031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ADBD1F0-BA3E-5A99-623F-AA9FAA8D78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105" y="122979"/>
            <a:ext cx="5409767" cy="179206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B5AEFF3-741C-0FDF-9BE6-89CE18E9C3CE}"/>
              </a:ext>
            </a:extLst>
          </p:cNvPr>
          <p:cNvSpPr txBox="1"/>
          <p:nvPr/>
        </p:nvSpPr>
        <p:spPr>
          <a:xfrm>
            <a:off x="66308" y="2326218"/>
            <a:ext cx="1612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Raw data——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6A0A2956-916D-B4A5-A620-D0F7DC680C19}"/>
              </a:ext>
            </a:extLst>
          </p:cNvPr>
          <p:cNvGrpSpPr/>
          <p:nvPr/>
        </p:nvGrpSpPr>
        <p:grpSpPr>
          <a:xfrm>
            <a:off x="1952285" y="2019868"/>
            <a:ext cx="5117255" cy="4838131"/>
            <a:chOff x="2654670" y="4159565"/>
            <a:chExt cx="2240133" cy="1898649"/>
          </a:xfrm>
        </p:grpSpPr>
        <p:pic>
          <p:nvPicPr>
            <p:cNvPr id="10" name="Picture 5" descr="C:\Users\APPLE\Desktop\nanoPNG-2_10.tif">
              <a:extLst>
                <a:ext uri="{FF2B5EF4-FFF2-40B4-BE49-F238E27FC236}">
                  <a16:creationId xmlns:a16="http://schemas.microsoft.com/office/drawing/2014/main" id="{65300809-CB3A-DB9F-E09E-5CB4C55B7B0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" t="-174" r="-49" b="587"/>
            <a:stretch/>
          </p:blipFill>
          <p:spPr bwMode="auto">
            <a:xfrm>
              <a:off x="2654670" y="4159565"/>
              <a:ext cx="2240133" cy="1898649"/>
            </a:xfrm>
            <a:prstGeom prst="rect">
              <a:avLst/>
            </a:prstGeom>
            <a:ln w="6350" cap="sq">
              <a:noFill/>
              <a:prstDash val="solid"/>
              <a:miter lim="800000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099459D1-F646-9D9A-5C36-CC9BA1303B95}"/>
                </a:ext>
              </a:extLst>
            </p:cNvPr>
            <p:cNvGrpSpPr/>
            <p:nvPr/>
          </p:nvGrpSpPr>
          <p:grpSpPr>
            <a:xfrm>
              <a:off x="3234581" y="4813675"/>
              <a:ext cx="179171" cy="120782"/>
              <a:chOff x="3271121" y="1511045"/>
              <a:chExt cx="179171" cy="120782"/>
            </a:xfrm>
          </p:grpSpPr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7FBAC659-7E70-3C3A-11E8-B0CEE16F2686}"/>
                  </a:ext>
                </a:extLst>
              </p:cNvPr>
              <p:cNvSpPr txBox="1"/>
              <p:nvPr/>
            </p:nvSpPr>
            <p:spPr>
              <a:xfrm>
                <a:off x="3271121" y="1511045"/>
                <a:ext cx="167854" cy="1207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70</a:t>
                </a:r>
                <a:endParaRPr kumimoji="0" lang="zh-CN" altLang="en-US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直接连接符 12">
                <a:extLst>
                  <a:ext uri="{FF2B5EF4-FFF2-40B4-BE49-F238E27FC236}">
                    <a16:creationId xmlns:a16="http://schemas.microsoft.com/office/drawing/2014/main" id="{3196DE1C-C122-761A-319B-592F2F698F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14292" y="1567301"/>
                <a:ext cx="36000" cy="176"/>
              </a:xfrm>
              <a:prstGeom prst="line">
                <a:avLst/>
              </a:prstGeom>
              <a:ln w="127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2030873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FBE0853-4A06-2D45-5A5F-84C98D89DE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302" y="165039"/>
            <a:ext cx="5386797" cy="17928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F5001AF-31FC-9F5F-4B08-F0379EE478D9}"/>
              </a:ext>
            </a:extLst>
          </p:cNvPr>
          <p:cNvSpPr txBox="1"/>
          <p:nvPr/>
        </p:nvSpPr>
        <p:spPr>
          <a:xfrm>
            <a:off x="66308" y="2326218"/>
            <a:ext cx="1612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Raw data——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3AC35CAA-9177-D698-5DAC-9742800BD84D}"/>
              </a:ext>
            </a:extLst>
          </p:cNvPr>
          <p:cNvGrpSpPr/>
          <p:nvPr/>
        </p:nvGrpSpPr>
        <p:grpSpPr>
          <a:xfrm>
            <a:off x="2501260" y="2558956"/>
            <a:ext cx="4983115" cy="4248702"/>
            <a:chOff x="2031835" y="4375878"/>
            <a:chExt cx="2216530" cy="1776687"/>
          </a:xfrm>
        </p:grpSpPr>
        <p:pic>
          <p:nvPicPr>
            <p:cNvPr id="7" name="Picture 2" descr="C:\Users\APPLE\Desktop\PNGaseF-2_6.tif">
              <a:extLst>
                <a:ext uri="{FF2B5EF4-FFF2-40B4-BE49-F238E27FC236}">
                  <a16:creationId xmlns:a16="http://schemas.microsoft.com/office/drawing/2014/main" id="{71C9C99B-0E96-38DA-E966-2B55016074D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302" t="-329" r="135" b="56"/>
            <a:stretch/>
          </p:blipFill>
          <p:spPr bwMode="auto">
            <a:xfrm>
              <a:off x="2031835" y="4375878"/>
              <a:ext cx="2216530" cy="17766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442D3424-1BBA-4711-F1C9-17DC527444FD}"/>
                </a:ext>
              </a:extLst>
            </p:cNvPr>
            <p:cNvGrpSpPr/>
            <p:nvPr/>
          </p:nvGrpSpPr>
          <p:grpSpPr>
            <a:xfrm>
              <a:off x="2384034" y="4871793"/>
              <a:ext cx="172330" cy="128704"/>
              <a:chOff x="3277962" y="1507620"/>
              <a:chExt cx="172330" cy="128704"/>
            </a:xfrm>
          </p:grpSpPr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D304E5F4-F088-C4A9-8C8C-5D35D475F283}"/>
                  </a:ext>
                </a:extLst>
              </p:cNvPr>
              <p:cNvSpPr txBox="1"/>
              <p:nvPr/>
            </p:nvSpPr>
            <p:spPr>
              <a:xfrm>
                <a:off x="3277962" y="1507620"/>
                <a:ext cx="170556" cy="1287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70</a:t>
                </a:r>
                <a:endParaRPr kumimoji="0" lang="zh-CN" altLang="en-US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0" name="直接连接符 9">
                <a:extLst>
                  <a:ext uri="{FF2B5EF4-FFF2-40B4-BE49-F238E27FC236}">
                    <a16:creationId xmlns:a16="http://schemas.microsoft.com/office/drawing/2014/main" id="{8463544F-7912-D0B2-FD1B-CDDF2A2BD3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14292" y="1567301"/>
                <a:ext cx="36000" cy="176"/>
              </a:xfrm>
              <a:prstGeom prst="line">
                <a:avLst/>
              </a:prstGeom>
              <a:ln w="127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5542028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0D7B4EE-9832-CDFE-BE87-72B63727BA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450" y="199995"/>
            <a:ext cx="5412147" cy="17928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93F4652-9145-343A-10DF-0B5E126BA0CE}"/>
              </a:ext>
            </a:extLst>
          </p:cNvPr>
          <p:cNvSpPr txBox="1"/>
          <p:nvPr/>
        </p:nvSpPr>
        <p:spPr>
          <a:xfrm>
            <a:off x="0" y="2735793"/>
            <a:ext cx="1612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Raw data——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447654DB-9AC9-260B-1092-617DB319A6E2}"/>
              </a:ext>
            </a:extLst>
          </p:cNvPr>
          <p:cNvGrpSpPr/>
          <p:nvPr/>
        </p:nvGrpSpPr>
        <p:grpSpPr>
          <a:xfrm>
            <a:off x="2358903" y="2966720"/>
            <a:ext cx="4099047" cy="3808730"/>
            <a:chOff x="1010945" y="4578210"/>
            <a:chExt cx="1062937" cy="998537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AF1900A4-FE7F-EC92-33B2-C74CD0DB9D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67" t="30883" r="35281" b="36914"/>
            <a:stretch/>
          </p:blipFill>
          <p:spPr>
            <a:xfrm>
              <a:off x="1010945" y="4578210"/>
              <a:ext cx="1062937" cy="998537"/>
            </a:xfrm>
            <a:prstGeom prst="rect">
              <a:avLst/>
            </a:prstGeom>
            <a:ln w="6350" cap="sq">
              <a:noFill/>
              <a:prstDash val="solid"/>
              <a:miter lim="800000"/>
            </a:ln>
            <a:effectLst/>
          </p:spPr>
        </p:pic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60375236-AB77-54EB-C67F-F0A208E8C28C}"/>
                </a:ext>
              </a:extLst>
            </p:cNvPr>
            <p:cNvGrpSpPr/>
            <p:nvPr/>
          </p:nvGrpSpPr>
          <p:grpSpPr>
            <a:xfrm>
              <a:off x="1136840" y="4987520"/>
              <a:ext cx="120985" cy="80690"/>
              <a:chOff x="1643206" y="4457912"/>
              <a:chExt cx="120985" cy="80690"/>
            </a:xfrm>
          </p:grpSpPr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16993A9F-6D61-270D-B465-15AB9B5DDC59}"/>
                  </a:ext>
                </a:extLst>
              </p:cNvPr>
              <p:cNvSpPr txBox="1"/>
              <p:nvPr/>
            </p:nvSpPr>
            <p:spPr>
              <a:xfrm>
                <a:off x="1643206" y="4457912"/>
                <a:ext cx="101373" cy="806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55</a:t>
                </a:r>
                <a:endParaRPr kumimoji="0" lang="zh-CN" altLang="en-US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8" name="直接连接符 7">
                <a:extLst>
                  <a:ext uri="{FF2B5EF4-FFF2-40B4-BE49-F238E27FC236}">
                    <a16:creationId xmlns:a16="http://schemas.microsoft.com/office/drawing/2014/main" id="{61D83D75-A4C9-750C-B1D4-7974C1C507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8191" y="4497649"/>
                <a:ext cx="36000" cy="176"/>
              </a:xfrm>
              <a:prstGeom prst="line">
                <a:avLst/>
              </a:prstGeom>
              <a:ln w="127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4441317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DC025547-C73E-D8AB-264C-2ABA0BFC3D68}"/>
              </a:ext>
            </a:extLst>
          </p:cNvPr>
          <p:cNvGrpSpPr/>
          <p:nvPr/>
        </p:nvGrpSpPr>
        <p:grpSpPr>
          <a:xfrm>
            <a:off x="2242215" y="2991134"/>
            <a:ext cx="3280008" cy="3343275"/>
            <a:chOff x="4956161" y="4254251"/>
            <a:chExt cx="990048" cy="745998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64610E89-0027-ECB1-F21F-B245B2C4DD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</a:blip>
            <a:srcRect l="37442" t="30115" r="38746" b="45354"/>
            <a:stretch/>
          </p:blipFill>
          <p:spPr>
            <a:xfrm>
              <a:off x="4956161" y="4254251"/>
              <a:ext cx="990048" cy="745998"/>
            </a:xfrm>
            <a:prstGeom prst="rect">
              <a:avLst/>
            </a:prstGeom>
            <a:ln w="6350" cap="sq">
              <a:noFill/>
              <a:prstDash val="solid"/>
              <a:miter lim="800000"/>
            </a:ln>
            <a:effectLst/>
          </p:spPr>
        </p:pic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3CBA0DC1-9160-33FA-32E4-525F32FEF911}"/>
                </a:ext>
              </a:extLst>
            </p:cNvPr>
            <p:cNvGrpSpPr/>
            <p:nvPr/>
          </p:nvGrpSpPr>
          <p:grpSpPr>
            <a:xfrm>
              <a:off x="4967010" y="4487919"/>
              <a:ext cx="136727" cy="68675"/>
              <a:chOff x="1327899" y="3588593"/>
              <a:chExt cx="136727" cy="68675"/>
            </a:xfrm>
          </p:grpSpPr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4D8B8657-E7E7-14EF-88FF-475BC9E00747}"/>
                  </a:ext>
                </a:extLst>
              </p:cNvPr>
              <p:cNvSpPr txBox="1"/>
              <p:nvPr/>
            </p:nvSpPr>
            <p:spPr>
              <a:xfrm>
                <a:off x="1327899" y="3588593"/>
                <a:ext cx="115738" cy="686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70</a:t>
                </a:r>
                <a:endParaRPr kumimoji="0" lang="zh-CN" altLang="en-US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5" name="直接连接符 4">
                <a:extLst>
                  <a:ext uri="{FF2B5EF4-FFF2-40B4-BE49-F238E27FC236}">
                    <a16:creationId xmlns:a16="http://schemas.microsoft.com/office/drawing/2014/main" id="{44526F37-2B30-61A6-28E8-A88FE8C309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28626" y="3620657"/>
                <a:ext cx="36000" cy="176"/>
              </a:xfrm>
              <a:prstGeom prst="line">
                <a:avLst/>
              </a:prstGeom>
              <a:ln w="127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pic>
        <p:nvPicPr>
          <p:cNvPr id="7" name="图片 6">
            <a:extLst>
              <a:ext uri="{FF2B5EF4-FFF2-40B4-BE49-F238E27FC236}">
                <a16:creationId xmlns:a16="http://schemas.microsoft.com/office/drawing/2014/main" id="{0D1954A7-CF62-CD38-38E5-5E550D1C64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8700" y="247056"/>
            <a:ext cx="6589023" cy="179280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9C09E993-8C61-38FC-823B-A05237D0BB67}"/>
              </a:ext>
            </a:extLst>
          </p:cNvPr>
          <p:cNvSpPr txBox="1"/>
          <p:nvPr/>
        </p:nvSpPr>
        <p:spPr>
          <a:xfrm>
            <a:off x="0" y="2735793"/>
            <a:ext cx="1612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Raw data——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36100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863D8AF-DC2D-2249-2556-F276410776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716" y="213283"/>
            <a:ext cx="5195772" cy="17928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54331E0-4BEB-2E71-1DD6-033092F35958}"/>
              </a:ext>
            </a:extLst>
          </p:cNvPr>
          <p:cNvSpPr txBox="1"/>
          <p:nvPr/>
        </p:nvSpPr>
        <p:spPr>
          <a:xfrm>
            <a:off x="0" y="2735793"/>
            <a:ext cx="1612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Raw data——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3092A70F-A94E-B08A-BB47-9D8547AB0F82}"/>
              </a:ext>
            </a:extLst>
          </p:cNvPr>
          <p:cNvGrpSpPr/>
          <p:nvPr/>
        </p:nvGrpSpPr>
        <p:grpSpPr>
          <a:xfrm>
            <a:off x="1818742" y="2941093"/>
            <a:ext cx="4377342" cy="3805321"/>
            <a:chOff x="1566259" y="3844476"/>
            <a:chExt cx="2838782" cy="2342379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4EC9664B-E27D-661A-14F0-7A0B06A214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25000"/>
                      </a14:imgEffect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" t="-115" r="62" b="-396"/>
            <a:stretch/>
          </p:blipFill>
          <p:spPr>
            <a:xfrm>
              <a:off x="1566259" y="3844476"/>
              <a:ext cx="2838782" cy="2342379"/>
            </a:xfrm>
            <a:prstGeom prst="rect">
              <a:avLst/>
            </a:prstGeom>
            <a:ln w="6350" cap="sq">
              <a:noFill/>
              <a:prstDash val="solid"/>
              <a:miter lim="800000"/>
            </a:ln>
            <a:effectLst/>
          </p:spPr>
        </p:pic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92C2F335-AE26-3F4F-FFEB-D1FC880B7726}"/>
                </a:ext>
              </a:extLst>
            </p:cNvPr>
            <p:cNvGrpSpPr/>
            <p:nvPr/>
          </p:nvGrpSpPr>
          <p:grpSpPr>
            <a:xfrm>
              <a:off x="2356893" y="4749377"/>
              <a:ext cx="248666" cy="189453"/>
              <a:chOff x="3205568" y="1476231"/>
              <a:chExt cx="248666" cy="189453"/>
            </a:xfrm>
          </p:grpSpPr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42BF378A-4C3C-76DC-6DFF-165FB61D8DB0}"/>
                  </a:ext>
                </a:extLst>
              </p:cNvPr>
              <p:cNvSpPr txBox="1"/>
              <p:nvPr/>
            </p:nvSpPr>
            <p:spPr>
              <a:xfrm>
                <a:off x="3205568" y="1476231"/>
                <a:ext cx="248666" cy="1894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70</a:t>
                </a:r>
                <a:endParaRPr kumimoji="0" lang="zh-CN" altLang="en-US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8" name="直接连接符 7">
                <a:extLst>
                  <a:ext uri="{FF2B5EF4-FFF2-40B4-BE49-F238E27FC236}">
                    <a16:creationId xmlns:a16="http://schemas.microsoft.com/office/drawing/2014/main" id="{51A9D2D1-6FF1-4547-636D-FD9F6C51FA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14292" y="1567301"/>
                <a:ext cx="36000" cy="176"/>
              </a:xfrm>
              <a:prstGeom prst="line">
                <a:avLst/>
              </a:prstGeom>
              <a:ln w="127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1462600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791DE19-63E1-1313-05E0-F444E74C30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651" y="337711"/>
            <a:ext cx="5020427" cy="1792800"/>
          </a:xfrm>
          <a:prstGeom prst="rect">
            <a:avLst/>
          </a:prstGeom>
        </p:spPr>
      </p:pic>
      <p:grpSp>
        <p:nvGrpSpPr>
          <p:cNvPr id="9" name="组合 8">
            <a:extLst>
              <a:ext uri="{FF2B5EF4-FFF2-40B4-BE49-F238E27FC236}">
                <a16:creationId xmlns:a16="http://schemas.microsoft.com/office/drawing/2014/main" id="{7AECA00E-B718-E594-783A-E624B8F2C626}"/>
              </a:ext>
            </a:extLst>
          </p:cNvPr>
          <p:cNvGrpSpPr/>
          <p:nvPr/>
        </p:nvGrpSpPr>
        <p:grpSpPr>
          <a:xfrm>
            <a:off x="1891919" y="3000375"/>
            <a:ext cx="3108705" cy="3777646"/>
            <a:chOff x="2225295" y="4370101"/>
            <a:chExt cx="1482436" cy="195072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3F284A1-0ADB-6AAA-959B-50056397E43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25295" y="4370101"/>
              <a:ext cx="1482436" cy="1950720"/>
            </a:xfrm>
            <a:prstGeom prst="rect">
              <a:avLst/>
            </a:prstGeom>
          </p:spPr>
        </p:pic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AFE4311B-44B7-8370-D721-3C8B9DA81537}"/>
                </a:ext>
              </a:extLst>
            </p:cNvPr>
            <p:cNvGrpSpPr/>
            <p:nvPr/>
          </p:nvGrpSpPr>
          <p:grpSpPr>
            <a:xfrm>
              <a:off x="2349144" y="5087218"/>
              <a:ext cx="189670" cy="158931"/>
              <a:chOff x="1274956" y="3542260"/>
              <a:chExt cx="189670" cy="158931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844AA3A2-2E83-B6E7-B58A-EE8CEC81B45F}"/>
                  </a:ext>
                </a:extLst>
              </p:cNvPr>
              <p:cNvSpPr txBox="1"/>
              <p:nvPr/>
            </p:nvSpPr>
            <p:spPr>
              <a:xfrm>
                <a:off x="1274956" y="3542260"/>
                <a:ext cx="182849" cy="158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70</a:t>
                </a:r>
                <a:endParaRPr kumimoji="0" lang="zh-CN" altLang="en-US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7" name="直接连接符 6">
                <a:extLst>
                  <a:ext uri="{FF2B5EF4-FFF2-40B4-BE49-F238E27FC236}">
                    <a16:creationId xmlns:a16="http://schemas.microsoft.com/office/drawing/2014/main" id="{16558EEC-9DC2-2E54-1170-E7729C52D4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28626" y="3620657"/>
                <a:ext cx="36000" cy="176"/>
              </a:xfrm>
              <a:prstGeom prst="line">
                <a:avLst/>
              </a:prstGeom>
              <a:ln w="127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EFA68265-7463-1D52-5B2C-352B3AF32E22}"/>
              </a:ext>
            </a:extLst>
          </p:cNvPr>
          <p:cNvSpPr txBox="1"/>
          <p:nvPr/>
        </p:nvSpPr>
        <p:spPr>
          <a:xfrm>
            <a:off x="0" y="2735793"/>
            <a:ext cx="1612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Raw data——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76315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3680628-5557-66EA-9719-D7B60C238C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" y="654310"/>
            <a:ext cx="4917970" cy="1792800"/>
          </a:xfrm>
          <a:prstGeom prst="rect">
            <a:avLst/>
          </a:prstGeom>
        </p:spPr>
      </p:pic>
      <p:grpSp>
        <p:nvGrpSpPr>
          <p:cNvPr id="9" name="组合 8">
            <a:extLst>
              <a:ext uri="{FF2B5EF4-FFF2-40B4-BE49-F238E27FC236}">
                <a16:creationId xmlns:a16="http://schemas.microsoft.com/office/drawing/2014/main" id="{CB950A25-F1CC-D3A0-5DD9-B30CF5F29F6F}"/>
              </a:ext>
            </a:extLst>
          </p:cNvPr>
          <p:cNvGrpSpPr/>
          <p:nvPr/>
        </p:nvGrpSpPr>
        <p:grpSpPr>
          <a:xfrm>
            <a:off x="1518746" y="3205162"/>
            <a:ext cx="3748579" cy="3362122"/>
            <a:chOff x="2749059" y="605227"/>
            <a:chExt cx="2123931" cy="1845669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F53A88CA-7AD4-700A-8DAD-5F27FF2A863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49059" y="605227"/>
              <a:ext cx="2123931" cy="1845669"/>
            </a:xfrm>
            <a:prstGeom prst="rect">
              <a:avLst/>
            </a:prstGeom>
          </p:spPr>
        </p:pic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AFD26EB0-12BF-E555-F748-88C96C6A0C9D}"/>
                </a:ext>
              </a:extLst>
            </p:cNvPr>
            <p:cNvGrpSpPr/>
            <p:nvPr/>
          </p:nvGrpSpPr>
          <p:grpSpPr>
            <a:xfrm>
              <a:off x="2996820" y="1339026"/>
              <a:ext cx="273566" cy="168957"/>
              <a:chOff x="1200980" y="3527648"/>
              <a:chExt cx="273566" cy="168957"/>
            </a:xfrm>
          </p:grpSpPr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7F525258-672A-EC49-7BD1-EF39156A5A28}"/>
                  </a:ext>
                </a:extLst>
              </p:cNvPr>
              <p:cNvSpPr txBox="1"/>
              <p:nvPr/>
            </p:nvSpPr>
            <p:spPr>
              <a:xfrm>
                <a:off x="1200980" y="3527648"/>
                <a:ext cx="273566" cy="1689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180</a:t>
                </a:r>
                <a:endParaRPr kumimoji="0" lang="zh-CN" altLang="en-US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直接连接符 12">
                <a:extLst>
                  <a:ext uri="{FF2B5EF4-FFF2-40B4-BE49-F238E27FC236}">
                    <a16:creationId xmlns:a16="http://schemas.microsoft.com/office/drawing/2014/main" id="{FAE7A8D9-285A-6196-182C-A4448CAB81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28626" y="3620657"/>
                <a:ext cx="36000" cy="176"/>
              </a:xfrm>
              <a:prstGeom prst="line">
                <a:avLst/>
              </a:prstGeom>
              <a:ln w="127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F4C8433A-7C7A-75CF-D715-D6872E287B58}"/>
              </a:ext>
            </a:extLst>
          </p:cNvPr>
          <p:cNvSpPr txBox="1"/>
          <p:nvPr/>
        </p:nvSpPr>
        <p:spPr>
          <a:xfrm>
            <a:off x="0" y="2735793"/>
            <a:ext cx="1612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Raw data——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821781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82AAB83-D254-2A8B-1FBE-2B38630789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943" y="370684"/>
            <a:ext cx="6212126" cy="1792800"/>
          </a:xfrm>
          <a:prstGeom prst="rect">
            <a:avLst/>
          </a:prstGeom>
        </p:spPr>
      </p:pic>
      <p:grpSp>
        <p:nvGrpSpPr>
          <p:cNvPr id="8" name="组合 7">
            <a:extLst>
              <a:ext uri="{FF2B5EF4-FFF2-40B4-BE49-F238E27FC236}">
                <a16:creationId xmlns:a16="http://schemas.microsoft.com/office/drawing/2014/main" id="{C80AADB7-DB57-3C4E-89EC-D04D0CD040C2}"/>
              </a:ext>
            </a:extLst>
          </p:cNvPr>
          <p:cNvGrpSpPr/>
          <p:nvPr/>
        </p:nvGrpSpPr>
        <p:grpSpPr>
          <a:xfrm>
            <a:off x="2079432" y="2792729"/>
            <a:ext cx="3809577" cy="3983383"/>
            <a:chOff x="3369234" y="4041732"/>
            <a:chExt cx="1144290" cy="116519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13034010-D6F3-F957-FD32-3D16B2E248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697" t="29352" r="36918" b="33752"/>
            <a:stretch/>
          </p:blipFill>
          <p:spPr>
            <a:xfrm>
              <a:off x="3505624" y="4041732"/>
              <a:ext cx="1007900" cy="1165190"/>
            </a:xfrm>
            <a:prstGeom prst="rect">
              <a:avLst/>
            </a:prstGeom>
            <a:ln w="6350" cap="sq">
              <a:noFill/>
              <a:prstDash val="solid"/>
              <a:miter lim="800000"/>
            </a:ln>
            <a:effectLst/>
          </p:spPr>
        </p:pic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72288DFF-2428-04CE-FFBD-149608F16EB6}"/>
                </a:ext>
              </a:extLst>
            </p:cNvPr>
            <p:cNvGrpSpPr/>
            <p:nvPr/>
          </p:nvGrpSpPr>
          <p:grpSpPr>
            <a:xfrm>
              <a:off x="3369234" y="4473688"/>
              <a:ext cx="207544" cy="113044"/>
              <a:chOff x="1257082" y="3567750"/>
              <a:chExt cx="207544" cy="113044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3C75F8A7-F021-A26C-AE0B-E281B0601BDC}"/>
                  </a:ext>
                </a:extLst>
              </p:cNvPr>
              <p:cNvSpPr txBox="1"/>
              <p:nvPr/>
            </p:nvSpPr>
            <p:spPr>
              <a:xfrm>
                <a:off x="1257082" y="3567750"/>
                <a:ext cx="172587" cy="1130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130</a:t>
                </a:r>
                <a:endParaRPr kumimoji="0" lang="zh-CN" altLang="en-US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7" name="直接连接符 6">
                <a:extLst>
                  <a:ext uri="{FF2B5EF4-FFF2-40B4-BE49-F238E27FC236}">
                    <a16:creationId xmlns:a16="http://schemas.microsoft.com/office/drawing/2014/main" id="{030B3221-87FB-6738-58C9-8872997250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28626" y="3620657"/>
                <a:ext cx="36000" cy="176"/>
              </a:xfrm>
              <a:prstGeom prst="line">
                <a:avLst/>
              </a:prstGeom>
              <a:ln w="127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9" name="文本框 8">
            <a:extLst>
              <a:ext uri="{FF2B5EF4-FFF2-40B4-BE49-F238E27FC236}">
                <a16:creationId xmlns:a16="http://schemas.microsoft.com/office/drawing/2014/main" id="{21956199-9179-6C83-661E-CB297CA661C8}"/>
              </a:ext>
            </a:extLst>
          </p:cNvPr>
          <p:cNvSpPr txBox="1"/>
          <p:nvPr/>
        </p:nvSpPr>
        <p:spPr>
          <a:xfrm>
            <a:off x="0" y="2735793"/>
            <a:ext cx="1612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Raw data——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358754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C6292A4-9198-8BEA-3D6E-9C5845BD90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184" y="131963"/>
            <a:ext cx="3553939" cy="1584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8F103BD-3F7D-87C6-681D-619C3D277C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73605" y="131963"/>
            <a:ext cx="3549203" cy="1584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449867F-40B0-5EE9-207F-00D3D19C53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01804" y="131963"/>
            <a:ext cx="3537522" cy="1584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8A9AD40-59FF-863E-1276-1ABA47831FB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9184" y="1765470"/>
            <a:ext cx="3575314" cy="1584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6BF60DF-278B-F02F-C1A5-96025812403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73605" y="1765470"/>
            <a:ext cx="3532816" cy="1584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C6F4B29B-C235-5B95-EEA5-5428425C866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11219" y="1765470"/>
            <a:ext cx="3528107" cy="158400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9F7F43C6-F7AC-41CF-D342-FF233B3C24F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9184" y="3439224"/>
            <a:ext cx="3570552" cy="1584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C8D7F306-A897-E204-DCD1-908F5572AD4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73605" y="3439224"/>
            <a:ext cx="3559844" cy="15840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09925E8C-A213-AACD-9857-EA307A81093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590123" y="3439224"/>
            <a:ext cx="3549203" cy="158400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984C069B-4B47-EA89-59DD-8280EA006DA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6008" y="5106574"/>
            <a:ext cx="3553937" cy="1584000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894DBD4C-D5DA-F01B-825F-14C5E1BCC196}"/>
              </a:ext>
            </a:extLst>
          </p:cNvPr>
          <p:cNvSpPr txBox="1"/>
          <p:nvPr/>
        </p:nvSpPr>
        <p:spPr>
          <a:xfrm>
            <a:off x="3814550" y="5813946"/>
            <a:ext cx="84946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2400" b="1" dirty="0"/>
              <a:t>对指出的所有流式图一一进行了核实，没有图像是重复使用的</a:t>
            </a:r>
          </a:p>
        </p:txBody>
      </p:sp>
    </p:spTree>
    <p:extLst>
      <p:ext uri="{BB962C8B-B14F-4D97-AF65-F5344CB8AC3E}">
        <p14:creationId xmlns:p14="http://schemas.microsoft.com/office/powerpoint/2010/main" val="876938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1</TotalTime>
  <Words>49</Words>
  <Application>Microsoft Office PowerPoint</Application>
  <PresentationFormat>宽屏</PresentationFormat>
  <Paragraphs>17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Li</dc:creator>
  <cp:lastModifiedBy>Li Li</cp:lastModifiedBy>
  <cp:revision>6</cp:revision>
  <dcterms:created xsi:type="dcterms:W3CDTF">2025-03-22T10:47:43Z</dcterms:created>
  <dcterms:modified xsi:type="dcterms:W3CDTF">2025-03-23T02:08:01Z</dcterms:modified>
</cp:coreProperties>
</file>